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737"/>
    <p:restoredTop sz="94640"/>
  </p:normalViewPr>
  <p:slideViewPr>
    <p:cSldViewPr snapToGrid="0" snapToObjects="1">
      <p:cViewPr>
        <p:scale>
          <a:sx n="77" d="100"/>
          <a:sy n="77" d="100"/>
        </p:scale>
        <p:origin x="640" y="8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79F41D-84F9-246C-412D-22BE9924FE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46625A-BE6A-D09D-C4CA-186AA06DCF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31C955-1464-5DF9-EF53-70D420BB0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34170-56D0-8E9C-F9F2-EE6163FE2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A458FD-3C9B-9666-C68C-D8E1FF94F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14056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BAE01-2CFE-A348-4911-1EDA8D43D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2862EB-5C32-030E-E467-38EA727ED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B23D48-1B89-A24D-062C-72D7AE3E1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324E8C-21D8-C5C3-918F-83253099E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F82A60-4A92-5E84-0954-C85A3F778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52644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779ED6-7E90-C449-B7E9-38831351C1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22894B-CC58-6EF9-D6BA-E3B04ED18B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87FEE-E49A-BFB5-35A0-90F1FE770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B6A25A-4515-D53B-7CAB-72780A51B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8F9BBA-D5B2-FCFC-F5CA-19D87DE0E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703680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AEB07-52AE-4699-0490-25A577E717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A8B33D-FAB5-86D2-9A7B-2650A405BE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C2853A-A40B-464B-3EA4-DE16D995B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78422B-3DB6-8622-4296-C638F3A7A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2AF9AD-CF3A-FB9A-C697-A7D438679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724997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83D35-54DC-0C41-BABE-0081B6E152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81D8EA-FA9C-1AA9-9DE7-7440A613A6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00820-3F60-0722-1AEF-C7C729121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1E0D6-698A-CD77-144A-4D670E2A8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A7BF9-7325-863A-1CF6-DCB455061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190909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9415B4-A4F2-76B6-E663-90981781B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E314A0-FF67-7A3A-CE2E-E5725E2BF0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9AEE66-9821-B965-C4FC-2653C01845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F90AEC-3C76-40B6-6101-2E96D9989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0326BE-8592-AE73-A6F8-B2C1E4946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D85053-79AE-BCA7-AA0F-4DE3E9DB9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90678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C846F1-1586-2FF1-E541-1F73E79D2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67A989-D22D-6584-49ED-CB022320F9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C3BA0F-9DF5-5C28-ECB7-B96F0EE5D4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D75988-9B3A-51F7-CAED-65DA2074AA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870A9B-6E89-9179-CC3F-D130B7ED83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ABA0AA-0A36-90D8-6FAD-0FBCB9B7B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177378-6686-65E1-AE90-4F7916925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8A449E-18C8-5743-D755-79719E1A6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73155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0D1BB-D984-809B-1E72-44F4ED23A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666F50-F3F9-894B-EB2C-B6E6CECB9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FD9E08-1572-328B-9A3B-7621B7F9B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80FDF3-85D8-3582-4EF4-FAB6F7D80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53557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1E34D3-ADD4-4F6C-81A7-6E53DD86C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6D5339-EA65-F64C-56CF-8E92D377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3C5F3F-B5FB-25FA-BE6B-B9B36D92D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82879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5E432-3BF4-456D-BB5F-EFB9FD3AB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0BDB8B-AAE6-B8D4-1564-773321E78B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076D64-127C-60DC-66B1-2F58EE03F7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AC91B9-7511-D51B-A884-E7663A7B3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4A72B5-8D68-BE97-01A0-A0EA95F39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4F889A-995D-79BB-0E68-FAD0A0A99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93910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9AF32-F0C7-161E-A511-AE4FB2E6B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AEAAE1-C059-F372-19F6-A29F141B21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47F2B3-C963-E109-6519-9BB933229F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84658D-4C78-025A-21C8-17AA2A61C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3CC634-C92D-7044-2524-461AB39E7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E0CA98-D63A-7865-5C23-281847DAF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317540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75BBF9-78D7-0573-BACF-B4743CDD9E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7E6872-C7E9-F64D-F44D-57AEC7229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344A82-D6CF-D5C6-5A40-E1E63E2017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410D1-F56B-8D48-8113-BF64049FFF7D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C81AC-C6F7-13EE-D4B6-FE1357107A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CA3740-6D12-9223-0490-5E66CF4216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5F338-CBDE-644B-B17C-00434551B1DF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235742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092D6FE-2D9C-DEF3-A8F9-E4B7CB8FDF55}"/>
              </a:ext>
            </a:extLst>
          </p:cNvPr>
          <p:cNvSpPr txBox="1"/>
          <p:nvPr/>
        </p:nvSpPr>
        <p:spPr>
          <a:xfrm>
            <a:off x="0" y="2164976"/>
            <a:ext cx="12192000" cy="1684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 S1</a:t>
            </a:r>
          </a:p>
          <a:p>
            <a:pPr algn="ctr">
              <a:lnSpc>
                <a:spcPct val="200000"/>
              </a:lnSpc>
            </a:pP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section of somatic and reproductive tissues </a:t>
            </a:r>
          </a:p>
        </p:txBody>
      </p:sp>
    </p:spTree>
    <p:extLst>
      <p:ext uri="{BB962C8B-B14F-4D97-AF65-F5344CB8AC3E}">
        <p14:creationId xmlns:p14="http://schemas.microsoft.com/office/powerpoint/2010/main" val="4262280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8825E70E-78CF-0465-C9DF-A9F1CB1321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09000"/>
            <a:ext cx="8967273" cy="5040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D43CC77-E0B7-57D2-CC48-CF195B966C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1870" y="1561491"/>
            <a:ext cx="3885082" cy="4029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9451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22C8AD5D-194A-0705-4990-40BDBED2CF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4314"/>
            <a:ext cx="8976625" cy="504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73B7882E-DD52-6053-8F7C-FA7945BEA9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1595" y="1803686"/>
            <a:ext cx="4016250" cy="39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971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8</TotalTime>
  <Words>13</Words>
  <Application>Microsoft Macintosh PowerPoint</Application>
  <PresentationFormat>Widescreen</PresentationFormat>
  <Paragraphs>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14</cp:revision>
  <dcterms:created xsi:type="dcterms:W3CDTF">2022-06-24T09:57:56Z</dcterms:created>
  <dcterms:modified xsi:type="dcterms:W3CDTF">2022-10-23T13:07:21Z</dcterms:modified>
</cp:coreProperties>
</file>